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411DF-2219-4A15-AC5C-282AC96D22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9C4A8-150F-48E4-8C91-771FEECACC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D02819-4007-4777-9F76-3852B28D84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D682D-A061-48A9-AA91-0AF98A1D90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0ED89-4530-4842-B48D-7086205A81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E328B-78F5-49C8-8E23-ABE6A60050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A9D29-EBF3-4B0B-9B22-FCE381965F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6A81C-E03A-4FDF-89B9-1AE03945CA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D8491-039B-425E-9C26-B9C6739130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B7B8F-A4F6-49C6-9398-2210912790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5ED83-B202-441C-9DC6-2465A00BD8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811E2-327F-4CFA-ADE6-CA4CB06CFA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0EF40D-A356-42E9-AE87-149FE9549D5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28600" y="281160"/>
          <a:ext cx="8534520" cy="3833640"/>
        </p:xfrm>
        <a:graphic>
          <a:graphicData uri="http://schemas.openxmlformats.org/drawingml/2006/table">
            <a:tbl>
              <a:tblPr/>
              <a:tblGrid>
                <a:gridCol w="914400"/>
                <a:gridCol w="457200"/>
                <a:gridCol w="380880"/>
                <a:gridCol w="685800"/>
                <a:gridCol w="2679840"/>
                <a:gridCol w="749160"/>
                <a:gridCol w="1279800"/>
                <a:gridCol w="701640"/>
                <a:gridCol w="685800"/>
              </a:tblGrid>
              <a:tr h="156240">
                <a:tc rowSpan="2"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a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total no.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8"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641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-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-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-2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-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-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&gt;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952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h1X 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 (Rv2968c, Rv3312c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v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/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s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, Rv3160c,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md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3161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872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h4X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(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t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g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, Rv2053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2052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(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316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(Rv3161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91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h1X(4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 (Rv1057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16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3161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532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h4X (48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 (Rv3252c,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g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,Rv2618,Rv1671,Rv1057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854c,Rv3614c,Rv0328,Rv1188,Rv0678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t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X, Rv1578c, Rv3615c, Rv239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 (hs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Rv106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Rv3066 ,Rv3160c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161c, e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1065 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532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h1X(45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 (Rv3160c, Rv118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Rv3066,Rv3160c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2745c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532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h4X(40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pq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 (Rv3161c,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A1, hsp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sat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, Rv316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2745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67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h1X(48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 (Rv3160c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hs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Rv0188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, Rv1188, Rv3615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3161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31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h4X(28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 (Rv3615c, Rv3616c, Rv2745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317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 (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sp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Rv0327c, Rv316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 (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m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161c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306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3600" marR="360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91"/>
          <p:cNvSpPr/>
          <p:nvPr/>
        </p:nvSpPr>
        <p:spPr>
          <a:xfrm>
            <a:off x="2951280" y="-75600"/>
            <a:ext cx="3518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S2 A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Genes induced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t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by THZ treatmen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228600" y="4462560"/>
          <a:ext cx="8534520" cy="2166840"/>
        </p:xfrm>
        <a:graphic>
          <a:graphicData uri="http://schemas.openxmlformats.org/drawingml/2006/table">
            <a:tbl>
              <a:tblPr/>
              <a:tblGrid>
                <a:gridCol w="982800"/>
                <a:gridCol w="534960"/>
                <a:gridCol w="446040"/>
                <a:gridCol w="2624040"/>
                <a:gridCol w="1817640"/>
                <a:gridCol w="677880"/>
                <a:gridCol w="1451160"/>
              </a:tblGrid>
              <a:tr h="162000"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ime a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eatme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total no.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ld chan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66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5-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-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-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-2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-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42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h1X 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 (Rv0195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co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, Rv1572c,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na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,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v0152c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d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17, Rv031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h4X 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(Rv2818c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u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,Rv0170,Rv2086,Rv180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(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c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3252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h1X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4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h4X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48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 (Rv2190c,Rv2950c, Rv031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h1X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9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245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h4X (33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Rv2142c,Rv1360, Rv2966c, 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th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, Rv207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h1X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41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(Rv245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20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h4X(21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 (Rv2074, Rv0696,</a:t>
                      </a: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s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1, Rv3130c, Rv2030c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Rectangle 73"/>
          <p:cNvSpPr/>
          <p:nvPr/>
        </p:nvSpPr>
        <p:spPr>
          <a:xfrm>
            <a:off x="2453400" y="4126680"/>
            <a:ext cx="3602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S2 B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Genes repressed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tb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by THZ treatmen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6T19:46:06Z</dcterms:created>
  <dc:creator>ndutta</dc:creator>
  <dc:description/>
  <dc:language>en-US</dc:language>
  <cp:lastModifiedBy>ndutta</cp:lastModifiedBy>
  <dcterms:modified xsi:type="dcterms:W3CDTF">2010-03-16T22:33:20Z</dcterms:modified>
  <cp:revision>53</cp:revision>
  <dc:subject/>
  <dc:title>Slide 1</dc:title>
</cp:coreProperties>
</file>